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5219700" cy="66595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97" userDrawn="1">
          <p15:clr>
            <a:srgbClr val="A4A3A4"/>
          </p15:clr>
        </p15:guide>
        <p15:guide id="2" pos="164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FAADC"/>
    <a:srgbClr val="2F528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4" autoAdjust="0"/>
    <p:restoredTop sz="94660"/>
  </p:normalViewPr>
  <p:slideViewPr>
    <p:cSldViewPr snapToGrid="0">
      <p:cViewPr>
        <p:scale>
          <a:sx n="120" d="100"/>
          <a:sy n="120" d="100"/>
        </p:scale>
        <p:origin x="1368" y="84"/>
      </p:cViewPr>
      <p:guideLst>
        <p:guide orient="horz" pos="2097"/>
        <p:guide pos="164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91478" y="1089887"/>
            <a:ext cx="4436745" cy="2318515"/>
          </a:xfrm>
        </p:spPr>
        <p:txBody>
          <a:bodyPr anchor="b"/>
          <a:lstStyle>
            <a:lvl1pPr algn="ctr">
              <a:defRPr sz="3425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52463" y="3497813"/>
            <a:ext cx="3914775" cy="1607852"/>
          </a:xfrm>
        </p:spPr>
        <p:txBody>
          <a:bodyPr/>
          <a:lstStyle>
            <a:lvl1pPr marL="0" indent="0" algn="ctr">
              <a:buNone/>
              <a:defRPr sz="1370"/>
            </a:lvl1pPr>
            <a:lvl2pPr marL="260970" indent="0" algn="ctr">
              <a:buNone/>
              <a:defRPr sz="1142"/>
            </a:lvl2pPr>
            <a:lvl3pPr marL="521940" indent="0" algn="ctr">
              <a:buNone/>
              <a:defRPr sz="1027"/>
            </a:lvl3pPr>
            <a:lvl4pPr marL="782909" indent="0" algn="ctr">
              <a:buNone/>
              <a:defRPr sz="913"/>
            </a:lvl4pPr>
            <a:lvl5pPr marL="1043879" indent="0" algn="ctr">
              <a:buNone/>
              <a:defRPr sz="913"/>
            </a:lvl5pPr>
            <a:lvl6pPr marL="1304849" indent="0" algn="ctr">
              <a:buNone/>
              <a:defRPr sz="913"/>
            </a:lvl6pPr>
            <a:lvl7pPr marL="1565819" indent="0" algn="ctr">
              <a:buNone/>
              <a:defRPr sz="913"/>
            </a:lvl7pPr>
            <a:lvl8pPr marL="1826788" indent="0" algn="ctr">
              <a:buNone/>
              <a:defRPr sz="913"/>
            </a:lvl8pPr>
            <a:lvl9pPr marL="2087758" indent="0" algn="ctr">
              <a:buNone/>
              <a:defRPr sz="913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F385B-C190-4F1B-B032-114AA3FA6370}" type="datetimeFigureOut">
              <a:rPr lang="es-MX" smtClean="0"/>
              <a:t>21/06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0876E-9FF6-452A-9239-5EFE7E4F581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5760302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F385B-C190-4F1B-B032-114AA3FA6370}" type="datetimeFigureOut">
              <a:rPr lang="es-MX" smtClean="0"/>
              <a:t>21/06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0876E-9FF6-452A-9239-5EFE7E4F581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2294945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35348" y="354560"/>
            <a:ext cx="1125498" cy="5643672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58855" y="354560"/>
            <a:ext cx="3311247" cy="5643672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F385B-C190-4F1B-B032-114AA3FA6370}" type="datetimeFigureOut">
              <a:rPr lang="es-MX" smtClean="0"/>
              <a:t>21/06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0876E-9FF6-452A-9239-5EFE7E4F581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241538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F385B-C190-4F1B-B032-114AA3FA6370}" type="datetimeFigureOut">
              <a:rPr lang="es-MX" smtClean="0"/>
              <a:t>21/06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0876E-9FF6-452A-9239-5EFE7E4F581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496745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6136" y="1660268"/>
            <a:ext cx="4501991" cy="2770193"/>
          </a:xfrm>
        </p:spPr>
        <p:txBody>
          <a:bodyPr anchor="b"/>
          <a:lstStyle>
            <a:lvl1pPr>
              <a:defRPr sz="3425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6136" y="4456668"/>
            <a:ext cx="4501991" cy="1456779"/>
          </a:xfrm>
        </p:spPr>
        <p:txBody>
          <a:bodyPr/>
          <a:lstStyle>
            <a:lvl1pPr marL="0" indent="0">
              <a:buNone/>
              <a:defRPr sz="1370">
                <a:solidFill>
                  <a:schemeClr val="tx1"/>
                </a:solidFill>
              </a:defRPr>
            </a:lvl1pPr>
            <a:lvl2pPr marL="260970" indent="0">
              <a:buNone/>
              <a:defRPr sz="1142">
                <a:solidFill>
                  <a:schemeClr val="tx1">
                    <a:tint val="75000"/>
                  </a:schemeClr>
                </a:solidFill>
              </a:defRPr>
            </a:lvl2pPr>
            <a:lvl3pPr marL="521940" indent="0">
              <a:buNone/>
              <a:defRPr sz="1027">
                <a:solidFill>
                  <a:schemeClr val="tx1">
                    <a:tint val="75000"/>
                  </a:schemeClr>
                </a:solidFill>
              </a:defRPr>
            </a:lvl3pPr>
            <a:lvl4pPr marL="782909" indent="0">
              <a:buNone/>
              <a:defRPr sz="913">
                <a:solidFill>
                  <a:schemeClr val="tx1">
                    <a:tint val="75000"/>
                  </a:schemeClr>
                </a:solidFill>
              </a:defRPr>
            </a:lvl4pPr>
            <a:lvl5pPr marL="1043879" indent="0">
              <a:buNone/>
              <a:defRPr sz="913">
                <a:solidFill>
                  <a:schemeClr val="tx1">
                    <a:tint val="75000"/>
                  </a:schemeClr>
                </a:solidFill>
              </a:defRPr>
            </a:lvl5pPr>
            <a:lvl6pPr marL="1304849" indent="0">
              <a:buNone/>
              <a:defRPr sz="913">
                <a:solidFill>
                  <a:schemeClr val="tx1">
                    <a:tint val="75000"/>
                  </a:schemeClr>
                </a:solidFill>
              </a:defRPr>
            </a:lvl6pPr>
            <a:lvl7pPr marL="1565819" indent="0">
              <a:buNone/>
              <a:defRPr sz="913">
                <a:solidFill>
                  <a:schemeClr val="tx1">
                    <a:tint val="75000"/>
                  </a:schemeClr>
                </a:solidFill>
              </a:defRPr>
            </a:lvl7pPr>
            <a:lvl8pPr marL="1826788" indent="0">
              <a:buNone/>
              <a:defRPr sz="913">
                <a:solidFill>
                  <a:schemeClr val="tx1">
                    <a:tint val="75000"/>
                  </a:schemeClr>
                </a:solidFill>
              </a:defRPr>
            </a:lvl8pPr>
            <a:lvl9pPr marL="2087758" indent="0">
              <a:buNone/>
              <a:defRPr sz="91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F385B-C190-4F1B-B032-114AA3FA6370}" type="datetimeFigureOut">
              <a:rPr lang="es-MX" smtClean="0"/>
              <a:t>21/06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0876E-9FF6-452A-9239-5EFE7E4F581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0542761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58854" y="1772800"/>
            <a:ext cx="2218373" cy="422543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42473" y="1772800"/>
            <a:ext cx="2218373" cy="422543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F385B-C190-4F1B-B032-114AA3FA6370}" type="datetimeFigureOut">
              <a:rPr lang="es-MX" smtClean="0"/>
              <a:t>21/06/2019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0876E-9FF6-452A-9239-5EFE7E4F581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219496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9534" y="354561"/>
            <a:ext cx="4501991" cy="1287208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9535" y="1632518"/>
            <a:ext cx="2208177" cy="800072"/>
          </a:xfrm>
        </p:spPr>
        <p:txBody>
          <a:bodyPr anchor="b"/>
          <a:lstStyle>
            <a:lvl1pPr marL="0" indent="0">
              <a:buNone/>
              <a:defRPr sz="1370" b="1"/>
            </a:lvl1pPr>
            <a:lvl2pPr marL="260970" indent="0">
              <a:buNone/>
              <a:defRPr sz="1142" b="1"/>
            </a:lvl2pPr>
            <a:lvl3pPr marL="521940" indent="0">
              <a:buNone/>
              <a:defRPr sz="1027" b="1"/>
            </a:lvl3pPr>
            <a:lvl4pPr marL="782909" indent="0">
              <a:buNone/>
              <a:defRPr sz="913" b="1"/>
            </a:lvl4pPr>
            <a:lvl5pPr marL="1043879" indent="0">
              <a:buNone/>
              <a:defRPr sz="913" b="1"/>
            </a:lvl5pPr>
            <a:lvl6pPr marL="1304849" indent="0">
              <a:buNone/>
              <a:defRPr sz="913" b="1"/>
            </a:lvl6pPr>
            <a:lvl7pPr marL="1565819" indent="0">
              <a:buNone/>
              <a:defRPr sz="913" b="1"/>
            </a:lvl7pPr>
            <a:lvl8pPr marL="1826788" indent="0">
              <a:buNone/>
              <a:defRPr sz="913" b="1"/>
            </a:lvl8pPr>
            <a:lvl9pPr marL="2087758" indent="0">
              <a:buNone/>
              <a:defRPr sz="913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9535" y="2432590"/>
            <a:ext cx="2208177" cy="357797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642474" y="1632518"/>
            <a:ext cx="2219052" cy="800072"/>
          </a:xfrm>
        </p:spPr>
        <p:txBody>
          <a:bodyPr anchor="b"/>
          <a:lstStyle>
            <a:lvl1pPr marL="0" indent="0">
              <a:buNone/>
              <a:defRPr sz="1370" b="1"/>
            </a:lvl1pPr>
            <a:lvl2pPr marL="260970" indent="0">
              <a:buNone/>
              <a:defRPr sz="1142" b="1"/>
            </a:lvl2pPr>
            <a:lvl3pPr marL="521940" indent="0">
              <a:buNone/>
              <a:defRPr sz="1027" b="1"/>
            </a:lvl3pPr>
            <a:lvl4pPr marL="782909" indent="0">
              <a:buNone/>
              <a:defRPr sz="913" b="1"/>
            </a:lvl4pPr>
            <a:lvl5pPr marL="1043879" indent="0">
              <a:buNone/>
              <a:defRPr sz="913" b="1"/>
            </a:lvl5pPr>
            <a:lvl6pPr marL="1304849" indent="0">
              <a:buNone/>
              <a:defRPr sz="913" b="1"/>
            </a:lvl6pPr>
            <a:lvl7pPr marL="1565819" indent="0">
              <a:buNone/>
              <a:defRPr sz="913" b="1"/>
            </a:lvl7pPr>
            <a:lvl8pPr marL="1826788" indent="0">
              <a:buNone/>
              <a:defRPr sz="913" b="1"/>
            </a:lvl8pPr>
            <a:lvl9pPr marL="2087758" indent="0">
              <a:buNone/>
              <a:defRPr sz="913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642474" y="2432590"/>
            <a:ext cx="2219052" cy="357797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F385B-C190-4F1B-B032-114AA3FA6370}" type="datetimeFigureOut">
              <a:rPr lang="es-MX" smtClean="0"/>
              <a:t>21/06/2019</a:t>
            </a:fld>
            <a:endParaRPr lang="es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0876E-9FF6-452A-9239-5EFE7E4F581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6615541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F385B-C190-4F1B-B032-114AA3FA6370}" type="datetimeFigureOut">
              <a:rPr lang="es-MX" smtClean="0"/>
              <a:t>21/06/2019</a:t>
            </a:fld>
            <a:endParaRPr lang="es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0876E-9FF6-452A-9239-5EFE7E4F581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212728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F385B-C190-4F1B-B032-114AA3FA6370}" type="datetimeFigureOut">
              <a:rPr lang="es-MX" smtClean="0"/>
              <a:t>21/06/2019</a:t>
            </a:fld>
            <a:endParaRPr lang="es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0876E-9FF6-452A-9239-5EFE7E4F581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417457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9534" y="443971"/>
            <a:ext cx="1683489" cy="1553898"/>
          </a:xfrm>
        </p:spPr>
        <p:txBody>
          <a:bodyPr anchor="b"/>
          <a:lstStyle>
            <a:lvl1pPr>
              <a:defRPr sz="1827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19052" y="958855"/>
            <a:ext cx="2642473" cy="4732606"/>
          </a:xfrm>
        </p:spPr>
        <p:txBody>
          <a:bodyPr/>
          <a:lstStyle>
            <a:lvl1pPr>
              <a:defRPr sz="1827"/>
            </a:lvl1pPr>
            <a:lvl2pPr>
              <a:defRPr sz="1598"/>
            </a:lvl2pPr>
            <a:lvl3pPr>
              <a:defRPr sz="1370"/>
            </a:lvl3pPr>
            <a:lvl4pPr>
              <a:defRPr sz="1142"/>
            </a:lvl4pPr>
            <a:lvl5pPr>
              <a:defRPr sz="1142"/>
            </a:lvl5pPr>
            <a:lvl6pPr>
              <a:defRPr sz="1142"/>
            </a:lvl6pPr>
            <a:lvl7pPr>
              <a:defRPr sz="1142"/>
            </a:lvl7pPr>
            <a:lvl8pPr>
              <a:defRPr sz="1142"/>
            </a:lvl8pPr>
            <a:lvl9pPr>
              <a:defRPr sz="1142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9534" y="1997869"/>
            <a:ext cx="1683489" cy="3701299"/>
          </a:xfrm>
        </p:spPr>
        <p:txBody>
          <a:bodyPr/>
          <a:lstStyle>
            <a:lvl1pPr marL="0" indent="0">
              <a:buNone/>
              <a:defRPr sz="913"/>
            </a:lvl1pPr>
            <a:lvl2pPr marL="260970" indent="0">
              <a:buNone/>
              <a:defRPr sz="799"/>
            </a:lvl2pPr>
            <a:lvl3pPr marL="521940" indent="0">
              <a:buNone/>
              <a:defRPr sz="685"/>
            </a:lvl3pPr>
            <a:lvl4pPr marL="782909" indent="0">
              <a:buNone/>
              <a:defRPr sz="571"/>
            </a:lvl4pPr>
            <a:lvl5pPr marL="1043879" indent="0">
              <a:buNone/>
              <a:defRPr sz="571"/>
            </a:lvl5pPr>
            <a:lvl6pPr marL="1304849" indent="0">
              <a:buNone/>
              <a:defRPr sz="571"/>
            </a:lvl6pPr>
            <a:lvl7pPr marL="1565819" indent="0">
              <a:buNone/>
              <a:defRPr sz="571"/>
            </a:lvl7pPr>
            <a:lvl8pPr marL="1826788" indent="0">
              <a:buNone/>
              <a:defRPr sz="571"/>
            </a:lvl8pPr>
            <a:lvl9pPr marL="2087758" indent="0">
              <a:buNone/>
              <a:defRPr sz="57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F385B-C190-4F1B-B032-114AA3FA6370}" type="datetimeFigureOut">
              <a:rPr lang="es-MX" smtClean="0"/>
              <a:t>21/06/2019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0876E-9FF6-452A-9239-5EFE7E4F581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255004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9534" y="443971"/>
            <a:ext cx="1683489" cy="1553898"/>
          </a:xfrm>
        </p:spPr>
        <p:txBody>
          <a:bodyPr anchor="b"/>
          <a:lstStyle>
            <a:lvl1pPr>
              <a:defRPr sz="1827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219052" y="958855"/>
            <a:ext cx="2642473" cy="4732606"/>
          </a:xfrm>
        </p:spPr>
        <p:txBody>
          <a:bodyPr anchor="t"/>
          <a:lstStyle>
            <a:lvl1pPr marL="0" indent="0">
              <a:buNone/>
              <a:defRPr sz="1827"/>
            </a:lvl1pPr>
            <a:lvl2pPr marL="260970" indent="0">
              <a:buNone/>
              <a:defRPr sz="1598"/>
            </a:lvl2pPr>
            <a:lvl3pPr marL="521940" indent="0">
              <a:buNone/>
              <a:defRPr sz="1370"/>
            </a:lvl3pPr>
            <a:lvl4pPr marL="782909" indent="0">
              <a:buNone/>
              <a:defRPr sz="1142"/>
            </a:lvl4pPr>
            <a:lvl5pPr marL="1043879" indent="0">
              <a:buNone/>
              <a:defRPr sz="1142"/>
            </a:lvl5pPr>
            <a:lvl6pPr marL="1304849" indent="0">
              <a:buNone/>
              <a:defRPr sz="1142"/>
            </a:lvl6pPr>
            <a:lvl7pPr marL="1565819" indent="0">
              <a:buNone/>
              <a:defRPr sz="1142"/>
            </a:lvl7pPr>
            <a:lvl8pPr marL="1826788" indent="0">
              <a:buNone/>
              <a:defRPr sz="1142"/>
            </a:lvl8pPr>
            <a:lvl9pPr marL="2087758" indent="0">
              <a:buNone/>
              <a:defRPr sz="1142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9534" y="1997869"/>
            <a:ext cx="1683489" cy="3701299"/>
          </a:xfrm>
        </p:spPr>
        <p:txBody>
          <a:bodyPr/>
          <a:lstStyle>
            <a:lvl1pPr marL="0" indent="0">
              <a:buNone/>
              <a:defRPr sz="913"/>
            </a:lvl1pPr>
            <a:lvl2pPr marL="260970" indent="0">
              <a:buNone/>
              <a:defRPr sz="799"/>
            </a:lvl2pPr>
            <a:lvl3pPr marL="521940" indent="0">
              <a:buNone/>
              <a:defRPr sz="685"/>
            </a:lvl3pPr>
            <a:lvl4pPr marL="782909" indent="0">
              <a:buNone/>
              <a:defRPr sz="571"/>
            </a:lvl4pPr>
            <a:lvl5pPr marL="1043879" indent="0">
              <a:buNone/>
              <a:defRPr sz="571"/>
            </a:lvl5pPr>
            <a:lvl6pPr marL="1304849" indent="0">
              <a:buNone/>
              <a:defRPr sz="571"/>
            </a:lvl6pPr>
            <a:lvl7pPr marL="1565819" indent="0">
              <a:buNone/>
              <a:defRPr sz="571"/>
            </a:lvl7pPr>
            <a:lvl8pPr marL="1826788" indent="0">
              <a:buNone/>
              <a:defRPr sz="571"/>
            </a:lvl8pPr>
            <a:lvl9pPr marL="2087758" indent="0">
              <a:buNone/>
              <a:defRPr sz="57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F385B-C190-4F1B-B032-114AA3FA6370}" type="datetimeFigureOut">
              <a:rPr lang="es-MX" smtClean="0"/>
              <a:t>21/06/2019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70876E-9FF6-452A-9239-5EFE7E4F581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724711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58855" y="354561"/>
            <a:ext cx="4501991" cy="12872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8855" y="1772800"/>
            <a:ext cx="4501991" cy="42254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58854" y="6172430"/>
            <a:ext cx="1174433" cy="35456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8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5F385B-C190-4F1B-B032-114AA3FA6370}" type="datetimeFigureOut">
              <a:rPr lang="es-MX" smtClean="0"/>
              <a:t>21/06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29026" y="6172430"/>
            <a:ext cx="1761649" cy="35456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8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686413" y="6172430"/>
            <a:ext cx="1174433" cy="35456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8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70876E-9FF6-452A-9239-5EFE7E4F581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8923004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521940" rtl="0" eaLnBrk="1" latinLnBrk="0" hangingPunct="1">
        <a:lnSpc>
          <a:spcPct val="90000"/>
        </a:lnSpc>
        <a:spcBef>
          <a:spcPct val="0"/>
        </a:spcBef>
        <a:buNone/>
        <a:defRPr sz="251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0485" indent="-130485" algn="l" defTabSz="521940" rtl="0" eaLnBrk="1" latinLnBrk="0" hangingPunct="1">
        <a:lnSpc>
          <a:spcPct val="90000"/>
        </a:lnSpc>
        <a:spcBef>
          <a:spcPts val="571"/>
        </a:spcBef>
        <a:buFont typeface="Arial" panose="020B0604020202020204" pitchFamily="34" charset="0"/>
        <a:buChar char="•"/>
        <a:defRPr sz="1598" kern="1200">
          <a:solidFill>
            <a:schemeClr val="tx1"/>
          </a:solidFill>
          <a:latin typeface="+mn-lt"/>
          <a:ea typeface="+mn-ea"/>
          <a:cs typeface="+mn-cs"/>
        </a:defRPr>
      </a:lvl1pPr>
      <a:lvl2pPr marL="391455" indent="-130485" algn="l" defTabSz="521940" rtl="0" eaLnBrk="1" latinLnBrk="0" hangingPunct="1">
        <a:lnSpc>
          <a:spcPct val="90000"/>
        </a:lnSpc>
        <a:spcBef>
          <a:spcPts val="285"/>
        </a:spcBef>
        <a:buFont typeface="Arial" panose="020B0604020202020204" pitchFamily="34" charset="0"/>
        <a:buChar char="•"/>
        <a:defRPr sz="1370" kern="1200">
          <a:solidFill>
            <a:schemeClr val="tx1"/>
          </a:solidFill>
          <a:latin typeface="+mn-lt"/>
          <a:ea typeface="+mn-ea"/>
          <a:cs typeface="+mn-cs"/>
        </a:defRPr>
      </a:lvl2pPr>
      <a:lvl3pPr marL="652424" indent="-130485" algn="l" defTabSz="521940" rtl="0" eaLnBrk="1" latinLnBrk="0" hangingPunct="1">
        <a:lnSpc>
          <a:spcPct val="90000"/>
        </a:lnSpc>
        <a:spcBef>
          <a:spcPts val="285"/>
        </a:spcBef>
        <a:buFont typeface="Arial" panose="020B0604020202020204" pitchFamily="34" charset="0"/>
        <a:buChar char="•"/>
        <a:defRPr sz="1142" kern="1200">
          <a:solidFill>
            <a:schemeClr val="tx1"/>
          </a:solidFill>
          <a:latin typeface="+mn-lt"/>
          <a:ea typeface="+mn-ea"/>
          <a:cs typeface="+mn-cs"/>
        </a:defRPr>
      </a:lvl3pPr>
      <a:lvl4pPr marL="913394" indent="-130485" algn="l" defTabSz="521940" rtl="0" eaLnBrk="1" latinLnBrk="0" hangingPunct="1">
        <a:lnSpc>
          <a:spcPct val="90000"/>
        </a:lnSpc>
        <a:spcBef>
          <a:spcPts val="285"/>
        </a:spcBef>
        <a:buFont typeface="Arial" panose="020B0604020202020204" pitchFamily="34" charset="0"/>
        <a:buChar char="•"/>
        <a:defRPr sz="1027" kern="1200">
          <a:solidFill>
            <a:schemeClr val="tx1"/>
          </a:solidFill>
          <a:latin typeface="+mn-lt"/>
          <a:ea typeface="+mn-ea"/>
          <a:cs typeface="+mn-cs"/>
        </a:defRPr>
      </a:lvl4pPr>
      <a:lvl5pPr marL="1174364" indent="-130485" algn="l" defTabSz="521940" rtl="0" eaLnBrk="1" latinLnBrk="0" hangingPunct="1">
        <a:lnSpc>
          <a:spcPct val="90000"/>
        </a:lnSpc>
        <a:spcBef>
          <a:spcPts val="285"/>
        </a:spcBef>
        <a:buFont typeface="Arial" panose="020B0604020202020204" pitchFamily="34" charset="0"/>
        <a:buChar char="•"/>
        <a:defRPr sz="1027" kern="1200">
          <a:solidFill>
            <a:schemeClr val="tx1"/>
          </a:solidFill>
          <a:latin typeface="+mn-lt"/>
          <a:ea typeface="+mn-ea"/>
          <a:cs typeface="+mn-cs"/>
        </a:defRPr>
      </a:lvl5pPr>
      <a:lvl6pPr marL="1435334" indent="-130485" algn="l" defTabSz="521940" rtl="0" eaLnBrk="1" latinLnBrk="0" hangingPunct="1">
        <a:lnSpc>
          <a:spcPct val="90000"/>
        </a:lnSpc>
        <a:spcBef>
          <a:spcPts val="285"/>
        </a:spcBef>
        <a:buFont typeface="Arial" panose="020B0604020202020204" pitchFamily="34" charset="0"/>
        <a:buChar char="•"/>
        <a:defRPr sz="1027" kern="1200">
          <a:solidFill>
            <a:schemeClr val="tx1"/>
          </a:solidFill>
          <a:latin typeface="+mn-lt"/>
          <a:ea typeface="+mn-ea"/>
          <a:cs typeface="+mn-cs"/>
        </a:defRPr>
      </a:lvl6pPr>
      <a:lvl7pPr marL="1696303" indent="-130485" algn="l" defTabSz="521940" rtl="0" eaLnBrk="1" latinLnBrk="0" hangingPunct="1">
        <a:lnSpc>
          <a:spcPct val="90000"/>
        </a:lnSpc>
        <a:spcBef>
          <a:spcPts val="285"/>
        </a:spcBef>
        <a:buFont typeface="Arial" panose="020B0604020202020204" pitchFamily="34" charset="0"/>
        <a:buChar char="•"/>
        <a:defRPr sz="1027" kern="1200">
          <a:solidFill>
            <a:schemeClr val="tx1"/>
          </a:solidFill>
          <a:latin typeface="+mn-lt"/>
          <a:ea typeface="+mn-ea"/>
          <a:cs typeface="+mn-cs"/>
        </a:defRPr>
      </a:lvl7pPr>
      <a:lvl8pPr marL="1957273" indent="-130485" algn="l" defTabSz="521940" rtl="0" eaLnBrk="1" latinLnBrk="0" hangingPunct="1">
        <a:lnSpc>
          <a:spcPct val="90000"/>
        </a:lnSpc>
        <a:spcBef>
          <a:spcPts val="285"/>
        </a:spcBef>
        <a:buFont typeface="Arial" panose="020B0604020202020204" pitchFamily="34" charset="0"/>
        <a:buChar char="•"/>
        <a:defRPr sz="1027" kern="1200">
          <a:solidFill>
            <a:schemeClr val="tx1"/>
          </a:solidFill>
          <a:latin typeface="+mn-lt"/>
          <a:ea typeface="+mn-ea"/>
          <a:cs typeface="+mn-cs"/>
        </a:defRPr>
      </a:lvl8pPr>
      <a:lvl9pPr marL="2218243" indent="-130485" algn="l" defTabSz="521940" rtl="0" eaLnBrk="1" latinLnBrk="0" hangingPunct="1">
        <a:lnSpc>
          <a:spcPct val="90000"/>
        </a:lnSpc>
        <a:spcBef>
          <a:spcPts val="285"/>
        </a:spcBef>
        <a:buFont typeface="Arial" panose="020B0604020202020204" pitchFamily="34" charset="0"/>
        <a:buChar char="•"/>
        <a:defRPr sz="102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21940" rtl="0" eaLnBrk="1" latinLnBrk="0" hangingPunct="1">
        <a:defRPr sz="1027" kern="1200">
          <a:solidFill>
            <a:schemeClr val="tx1"/>
          </a:solidFill>
          <a:latin typeface="+mn-lt"/>
          <a:ea typeface="+mn-ea"/>
          <a:cs typeface="+mn-cs"/>
        </a:defRPr>
      </a:lvl1pPr>
      <a:lvl2pPr marL="260970" algn="l" defTabSz="521940" rtl="0" eaLnBrk="1" latinLnBrk="0" hangingPunct="1">
        <a:defRPr sz="1027" kern="1200">
          <a:solidFill>
            <a:schemeClr val="tx1"/>
          </a:solidFill>
          <a:latin typeface="+mn-lt"/>
          <a:ea typeface="+mn-ea"/>
          <a:cs typeface="+mn-cs"/>
        </a:defRPr>
      </a:lvl2pPr>
      <a:lvl3pPr marL="521940" algn="l" defTabSz="521940" rtl="0" eaLnBrk="1" latinLnBrk="0" hangingPunct="1">
        <a:defRPr sz="1027" kern="1200">
          <a:solidFill>
            <a:schemeClr val="tx1"/>
          </a:solidFill>
          <a:latin typeface="+mn-lt"/>
          <a:ea typeface="+mn-ea"/>
          <a:cs typeface="+mn-cs"/>
        </a:defRPr>
      </a:lvl3pPr>
      <a:lvl4pPr marL="782909" algn="l" defTabSz="521940" rtl="0" eaLnBrk="1" latinLnBrk="0" hangingPunct="1">
        <a:defRPr sz="1027" kern="1200">
          <a:solidFill>
            <a:schemeClr val="tx1"/>
          </a:solidFill>
          <a:latin typeface="+mn-lt"/>
          <a:ea typeface="+mn-ea"/>
          <a:cs typeface="+mn-cs"/>
        </a:defRPr>
      </a:lvl4pPr>
      <a:lvl5pPr marL="1043879" algn="l" defTabSz="521940" rtl="0" eaLnBrk="1" latinLnBrk="0" hangingPunct="1">
        <a:defRPr sz="1027" kern="1200">
          <a:solidFill>
            <a:schemeClr val="tx1"/>
          </a:solidFill>
          <a:latin typeface="+mn-lt"/>
          <a:ea typeface="+mn-ea"/>
          <a:cs typeface="+mn-cs"/>
        </a:defRPr>
      </a:lvl5pPr>
      <a:lvl6pPr marL="1304849" algn="l" defTabSz="521940" rtl="0" eaLnBrk="1" latinLnBrk="0" hangingPunct="1">
        <a:defRPr sz="1027" kern="1200">
          <a:solidFill>
            <a:schemeClr val="tx1"/>
          </a:solidFill>
          <a:latin typeface="+mn-lt"/>
          <a:ea typeface="+mn-ea"/>
          <a:cs typeface="+mn-cs"/>
        </a:defRPr>
      </a:lvl6pPr>
      <a:lvl7pPr marL="1565819" algn="l" defTabSz="521940" rtl="0" eaLnBrk="1" latinLnBrk="0" hangingPunct="1">
        <a:defRPr sz="1027" kern="1200">
          <a:solidFill>
            <a:schemeClr val="tx1"/>
          </a:solidFill>
          <a:latin typeface="+mn-lt"/>
          <a:ea typeface="+mn-ea"/>
          <a:cs typeface="+mn-cs"/>
        </a:defRPr>
      </a:lvl7pPr>
      <a:lvl8pPr marL="1826788" algn="l" defTabSz="521940" rtl="0" eaLnBrk="1" latinLnBrk="0" hangingPunct="1">
        <a:defRPr sz="1027" kern="1200">
          <a:solidFill>
            <a:schemeClr val="tx1"/>
          </a:solidFill>
          <a:latin typeface="+mn-lt"/>
          <a:ea typeface="+mn-ea"/>
          <a:cs typeface="+mn-cs"/>
        </a:defRPr>
      </a:lvl8pPr>
      <a:lvl9pPr marL="2087758" algn="l" defTabSz="521940" rtl="0" eaLnBrk="1" latinLnBrk="0" hangingPunct="1">
        <a:defRPr sz="102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o 2">
            <a:extLst>
              <a:ext uri="{FF2B5EF4-FFF2-40B4-BE49-F238E27FC236}">
                <a16:creationId xmlns:a16="http://schemas.microsoft.com/office/drawing/2014/main" id="{5A67A79C-0BCB-4D82-B153-E6409644FA33}"/>
              </a:ext>
            </a:extLst>
          </p:cNvPr>
          <p:cNvGrpSpPr/>
          <p:nvPr/>
        </p:nvGrpSpPr>
        <p:grpSpPr>
          <a:xfrm>
            <a:off x="180168" y="195510"/>
            <a:ext cx="4836169" cy="6257998"/>
            <a:chOff x="1450201" y="357955"/>
            <a:chExt cx="4836169" cy="6257998"/>
          </a:xfrm>
        </p:grpSpPr>
        <p:sp>
          <p:nvSpPr>
            <p:cNvPr id="4" name="Rectángulo 3">
              <a:extLst>
                <a:ext uri="{FF2B5EF4-FFF2-40B4-BE49-F238E27FC236}">
                  <a16:creationId xmlns:a16="http://schemas.microsoft.com/office/drawing/2014/main" id="{C079130F-94D2-477B-B6AE-5EDE68506F7C}"/>
                </a:ext>
              </a:extLst>
            </p:cNvPr>
            <p:cNvSpPr/>
            <p:nvPr/>
          </p:nvSpPr>
          <p:spPr>
            <a:xfrm>
              <a:off x="1450203" y="357955"/>
              <a:ext cx="387773" cy="1306447"/>
            </a:xfrm>
            <a:prstGeom prst="rect">
              <a:avLst/>
            </a:prstGeom>
            <a:solidFill>
              <a:srgbClr val="8FAADC"/>
            </a:solidFill>
            <a:ln w="381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vert270" wrap="square" lIns="121920" tIns="60960" rIns="121920" bIns="6096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s-MX" sz="1400" dirty="0">
                  <a:ea typeface="Calibri" panose="020F0502020204030204" pitchFamily="34" charset="0"/>
                  <a:cs typeface="Times New Roman" panose="02020603050405020304" pitchFamily="18" charset="0"/>
                </a:rPr>
                <a:t>IDENTIFICATION</a:t>
              </a:r>
            </a:p>
          </p:txBody>
        </p:sp>
        <p:sp>
          <p:nvSpPr>
            <p:cNvPr id="5" name="Rectángulo 4">
              <a:extLst>
                <a:ext uri="{FF2B5EF4-FFF2-40B4-BE49-F238E27FC236}">
                  <a16:creationId xmlns:a16="http://schemas.microsoft.com/office/drawing/2014/main" id="{C990133D-E344-4A1E-898D-476C0BE290A3}"/>
                </a:ext>
              </a:extLst>
            </p:cNvPr>
            <p:cNvSpPr/>
            <p:nvPr/>
          </p:nvSpPr>
          <p:spPr>
            <a:xfrm>
              <a:off x="1450203" y="1758197"/>
              <a:ext cx="387773" cy="1079132"/>
            </a:xfrm>
            <a:prstGeom prst="rect">
              <a:avLst/>
            </a:prstGeom>
            <a:solidFill>
              <a:srgbClr val="8FAADC"/>
            </a:solidFill>
            <a:ln w="381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vert270" wrap="square" lIns="121920" tIns="60960" rIns="121920" bIns="6096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s-MX" sz="1400" dirty="0">
                  <a:ea typeface="Calibri" panose="020F0502020204030204" pitchFamily="34" charset="0"/>
                  <a:cs typeface="Times New Roman" panose="02020603050405020304" pitchFamily="18" charset="0"/>
                </a:rPr>
                <a:t>SCREENING</a:t>
              </a:r>
            </a:p>
          </p:txBody>
        </p:sp>
        <p:sp>
          <p:nvSpPr>
            <p:cNvPr id="6" name="Rectángulo 5">
              <a:extLst>
                <a:ext uri="{FF2B5EF4-FFF2-40B4-BE49-F238E27FC236}">
                  <a16:creationId xmlns:a16="http://schemas.microsoft.com/office/drawing/2014/main" id="{83E4B7DC-2693-41C8-AE1B-FC8CEE629856}"/>
                </a:ext>
              </a:extLst>
            </p:cNvPr>
            <p:cNvSpPr/>
            <p:nvPr/>
          </p:nvSpPr>
          <p:spPr>
            <a:xfrm>
              <a:off x="2035212" y="357955"/>
              <a:ext cx="1660487" cy="692150"/>
            </a:xfrm>
            <a:prstGeom prst="rect">
              <a:avLst/>
            </a:prstGeom>
            <a:solidFill>
              <a:schemeClr val="accent1">
                <a:alpha val="0"/>
              </a:schemeClr>
            </a:solidFill>
            <a:ln w="38100">
              <a:solidFill>
                <a:srgbClr val="2F528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200" dirty="0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Records identified</a:t>
              </a:r>
            </a:p>
            <a:p>
              <a:pPr algn="ctr"/>
              <a:r>
                <a:rPr lang="en-US" sz="1200" dirty="0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(n = 527)</a:t>
              </a:r>
              <a:endParaRPr lang="es-MX" sz="1200" dirty="0"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ctángulo 6">
              <a:extLst>
                <a:ext uri="{FF2B5EF4-FFF2-40B4-BE49-F238E27FC236}">
                  <a16:creationId xmlns:a16="http://schemas.microsoft.com/office/drawing/2014/main" id="{44FC522E-E5A8-4DF6-A175-16BBBD34E99A}"/>
                </a:ext>
              </a:extLst>
            </p:cNvPr>
            <p:cNvSpPr/>
            <p:nvPr/>
          </p:nvSpPr>
          <p:spPr>
            <a:xfrm>
              <a:off x="2035212" y="1758197"/>
              <a:ext cx="1660487" cy="813714"/>
            </a:xfrm>
            <a:prstGeom prst="rect">
              <a:avLst/>
            </a:prstGeom>
            <a:solidFill>
              <a:schemeClr val="accent1">
                <a:alpha val="0"/>
              </a:schemeClr>
            </a:solidFill>
            <a:ln w="381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200" dirty="0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Records screened</a:t>
              </a:r>
            </a:p>
            <a:p>
              <a:pPr algn="ctr"/>
              <a:r>
                <a:rPr lang="en-US" sz="1200" dirty="0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(n = 527)</a:t>
              </a:r>
            </a:p>
          </p:txBody>
        </p:sp>
        <p:sp>
          <p:nvSpPr>
            <p:cNvPr id="9" name="Rectángulo 8">
              <a:extLst>
                <a:ext uri="{FF2B5EF4-FFF2-40B4-BE49-F238E27FC236}">
                  <a16:creationId xmlns:a16="http://schemas.microsoft.com/office/drawing/2014/main" id="{FC7CF4C2-AA3F-4C15-9FF4-27A3B2FC4B75}"/>
                </a:ext>
              </a:extLst>
            </p:cNvPr>
            <p:cNvSpPr/>
            <p:nvPr/>
          </p:nvSpPr>
          <p:spPr>
            <a:xfrm>
              <a:off x="2035209" y="2927975"/>
              <a:ext cx="1660487" cy="813714"/>
            </a:xfrm>
            <a:prstGeom prst="rect">
              <a:avLst/>
            </a:prstGeom>
            <a:solidFill>
              <a:schemeClr val="accent1">
                <a:alpha val="0"/>
              </a:schemeClr>
            </a:solidFill>
            <a:ln w="381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200" dirty="0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Full-text articles reviewed</a:t>
              </a:r>
            </a:p>
            <a:p>
              <a:pPr algn="ctr"/>
              <a:r>
                <a:rPr lang="en-US" sz="1200" dirty="0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(n = 38)</a:t>
              </a:r>
            </a:p>
          </p:txBody>
        </p:sp>
        <p:cxnSp>
          <p:nvCxnSpPr>
            <p:cNvPr id="27" name="Conector recto de flecha 26">
              <a:extLst>
                <a:ext uri="{FF2B5EF4-FFF2-40B4-BE49-F238E27FC236}">
                  <a16:creationId xmlns:a16="http://schemas.microsoft.com/office/drawing/2014/main" id="{AF587D7E-A438-466F-B17B-7B46271CFBE3}"/>
                </a:ext>
              </a:extLst>
            </p:cNvPr>
            <p:cNvCxnSpPr>
              <a:cxnSpLocks/>
              <a:stCxn id="6" idx="2"/>
              <a:endCxn id="7" idx="0"/>
            </p:cNvCxnSpPr>
            <p:nvPr/>
          </p:nvCxnSpPr>
          <p:spPr>
            <a:xfrm>
              <a:off x="2865456" y="1050105"/>
              <a:ext cx="0" cy="708092"/>
            </a:xfrm>
            <a:prstGeom prst="straightConnector1">
              <a:avLst/>
            </a:prstGeom>
            <a:ln w="38100">
              <a:solidFill>
                <a:srgbClr val="2F528F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Rectángulo 31">
              <a:extLst>
                <a:ext uri="{FF2B5EF4-FFF2-40B4-BE49-F238E27FC236}">
                  <a16:creationId xmlns:a16="http://schemas.microsoft.com/office/drawing/2014/main" id="{37CE6663-4F45-45EC-8B46-A31F08CA158A}"/>
                </a:ext>
              </a:extLst>
            </p:cNvPr>
            <p:cNvSpPr/>
            <p:nvPr/>
          </p:nvSpPr>
          <p:spPr>
            <a:xfrm>
              <a:off x="4355816" y="1758197"/>
              <a:ext cx="1660487" cy="813714"/>
            </a:xfrm>
            <a:prstGeom prst="rect">
              <a:avLst/>
            </a:prstGeom>
            <a:solidFill>
              <a:schemeClr val="accent1">
                <a:alpha val="0"/>
              </a:schemeClr>
            </a:solidFill>
            <a:ln w="381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200" dirty="0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Records excluded</a:t>
              </a:r>
            </a:p>
            <a:p>
              <a:pPr algn="ctr"/>
              <a:r>
                <a:rPr lang="en-US" sz="1200" dirty="0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(n = 489)</a:t>
              </a:r>
            </a:p>
          </p:txBody>
        </p:sp>
        <p:cxnSp>
          <p:nvCxnSpPr>
            <p:cNvPr id="33" name="Conector recto de flecha 32">
              <a:extLst>
                <a:ext uri="{FF2B5EF4-FFF2-40B4-BE49-F238E27FC236}">
                  <a16:creationId xmlns:a16="http://schemas.microsoft.com/office/drawing/2014/main" id="{EC397F92-4FBB-420C-9A27-89718FC53455}"/>
                </a:ext>
              </a:extLst>
            </p:cNvPr>
            <p:cNvCxnSpPr>
              <a:cxnSpLocks/>
              <a:stCxn id="7" idx="3"/>
              <a:endCxn id="32" idx="1"/>
            </p:cNvCxnSpPr>
            <p:nvPr/>
          </p:nvCxnSpPr>
          <p:spPr>
            <a:xfrm>
              <a:off x="3695699" y="2165054"/>
              <a:ext cx="660117" cy="0"/>
            </a:xfrm>
            <a:prstGeom prst="straightConnector1">
              <a:avLst/>
            </a:prstGeom>
            <a:ln w="38100">
              <a:solidFill>
                <a:srgbClr val="2F528F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Conector recto de flecha 37">
              <a:extLst>
                <a:ext uri="{FF2B5EF4-FFF2-40B4-BE49-F238E27FC236}">
                  <a16:creationId xmlns:a16="http://schemas.microsoft.com/office/drawing/2014/main" id="{681F18F5-4B79-4B53-9733-116FEA2D4CB4}"/>
                </a:ext>
              </a:extLst>
            </p:cNvPr>
            <p:cNvCxnSpPr>
              <a:cxnSpLocks/>
              <a:stCxn id="7" idx="2"/>
              <a:endCxn id="9" idx="0"/>
            </p:cNvCxnSpPr>
            <p:nvPr/>
          </p:nvCxnSpPr>
          <p:spPr>
            <a:xfrm flipH="1">
              <a:off x="2865453" y="2571911"/>
              <a:ext cx="3" cy="356064"/>
            </a:xfrm>
            <a:prstGeom prst="straightConnector1">
              <a:avLst/>
            </a:prstGeom>
            <a:ln w="38100">
              <a:solidFill>
                <a:srgbClr val="2F528F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Rectángulo 38">
              <a:extLst>
                <a:ext uri="{FF2B5EF4-FFF2-40B4-BE49-F238E27FC236}">
                  <a16:creationId xmlns:a16="http://schemas.microsoft.com/office/drawing/2014/main" id="{FA8BEB57-D61C-4517-91AF-CC970620E248}"/>
                </a:ext>
              </a:extLst>
            </p:cNvPr>
            <p:cNvSpPr/>
            <p:nvPr/>
          </p:nvSpPr>
          <p:spPr>
            <a:xfrm>
              <a:off x="4085742" y="2927975"/>
              <a:ext cx="2200628" cy="1858029"/>
            </a:xfrm>
            <a:prstGeom prst="rect">
              <a:avLst/>
            </a:prstGeom>
            <a:solidFill>
              <a:schemeClr val="accent1">
                <a:alpha val="0"/>
              </a:schemeClr>
            </a:solidFill>
            <a:ln w="381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200" dirty="0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Full-text articles excluded</a:t>
              </a:r>
            </a:p>
            <a:p>
              <a:pPr algn="ctr"/>
              <a:r>
                <a:rPr lang="en-US" sz="1200" dirty="0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(n = 27)</a:t>
              </a:r>
            </a:p>
            <a:p>
              <a:pPr algn="ctr"/>
              <a:r>
                <a:rPr lang="en-US" sz="1200" dirty="0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13 predominant adult population</a:t>
              </a:r>
            </a:p>
            <a:p>
              <a:pPr algn="ctr"/>
              <a:r>
                <a:rPr lang="en-US" sz="1200" dirty="0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8 not focus on caregivers</a:t>
              </a:r>
            </a:p>
            <a:p>
              <a:pPr algn="ctr"/>
              <a:r>
                <a:rPr lang="en-US" sz="1200" dirty="0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4 not focused on impact of the disease</a:t>
              </a:r>
            </a:p>
            <a:p>
              <a:pPr algn="ctr"/>
              <a:r>
                <a:rPr lang="en-US" sz="1200" dirty="0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2 not focused on chronic disease</a:t>
              </a:r>
            </a:p>
          </p:txBody>
        </p:sp>
        <p:cxnSp>
          <p:nvCxnSpPr>
            <p:cNvPr id="43" name="Conector recto de flecha 42">
              <a:extLst>
                <a:ext uri="{FF2B5EF4-FFF2-40B4-BE49-F238E27FC236}">
                  <a16:creationId xmlns:a16="http://schemas.microsoft.com/office/drawing/2014/main" id="{8518ECA0-A244-4135-81AD-3A88D9A27B8B}"/>
                </a:ext>
              </a:extLst>
            </p:cNvPr>
            <p:cNvCxnSpPr>
              <a:cxnSpLocks/>
              <a:stCxn id="9" idx="3"/>
            </p:cNvCxnSpPr>
            <p:nvPr/>
          </p:nvCxnSpPr>
          <p:spPr>
            <a:xfrm>
              <a:off x="3695696" y="3334832"/>
              <a:ext cx="390046" cy="0"/>
            </a:xfrm>
            <a:prstGeom prst="straightConnector1">
              <a:avLst/>
            </a:prstGeom>
            <a:ln w="38100">
              <a:solidFill>
                <a:srgbClr val="2F528F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Rectángulo 44">
              <a:extLst>
                <a:ext uri="{FF2B5EF4-FFF2-40B4-BE49-F238E27FC236}">
                  <a16:creationId xmlns:a16="http://schemas.microsoft.com/office/drawing/2014/main" id="{04E7E4B0-108B-4519-88F3-0A936F417D34}"/>
                </a:ext>
              </a:extLst>
            </p:cNvPr>
            <p:cNvSpPr/>
            <p:nvPr/>
          </p:nvSpPr>
          <p:spPr>
            <a:xfrm>
              <a:off x="2035211" y="5802239"/>
              <a:ext cx="1660487" cy="813714"/>
            </a:xfrm>
            <a:prstGeom prst="rect">
              <a:avLst/>
            </a:prstGeom>
            <a:solidFill>
              <a:schemeClr val="accent1">
                <a:alpha val="0"/>
              </a:schemeClr>
            </a:solidFill>
            <a:ln w="381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200" dirty="0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Articles included to develop the instrument</a:t>
              </a:r>
            </a:p>
            <a:p>
              <a:pPr algn="ctr"/>
              <a:r>
                <a:rPr lang="en-US" sz="1200" dirty="0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(n = 12)</a:t>
              </a:r>
            </a:p>
          </p:txBody>
        </p:sp>
        <p:cxnSp>
          <p:nvCxnSpPr>
            <p:cNvPr id="46" name="Conector recto de flecha 45">
              <a:extLst>
                <a:ext uri="{FF2B5EF4-FFF2-40B4-BE49-F238E27FC236}">
                  <a16:creationId xmlns:a16="http://schemas.microsoft.com/office/drawing/2014/main" id="{7B9540BD-8C6D-4198-94D7-A4601D748B0C}"/>
                </a:ext>
              </a:extLst>
            </p:cNvPr>
            <p:cNvCxnSpPr>
              <a:cxnSpLocks/>
              <a:stCxn id="9" idx="2"/>
              <a:endCxn id="45" idx="0"/>
            </p:cNvCxnSpPr>
            <p:nvPr/>
          </p:nvCxnSpPr>
          <p:spPr>
            <a:xfrm>
              <a:off x="2865453" y="3741689"/>
              <a:ext cx="2" cy="2060550"/>
            </a:xfrm>
            <a:prstGeom prst="straightConnector1">
              <a:avLst/>
            </a:prstGeom>
            <a:ln w="38100">
              <a:solidFill>
                <a:srgbClr val="2F528F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Rectángulo 49">
              <a:extLst>
                <a:ext uri="{FF2B5EF4-FFF2-40B4-BE49-F238E27FC236}">
                  <a16:creationId xmlns:a16="http://schemas.microsoft.com/office/drawing/2014/main" id="{B638E4E8-F988-4A46-9325-FE7A97BA5C82}"/>
                </a:ext>
              </a:extLst>
            </p:cNvPr>
            <p:cNvSpPr/>
            <p:nvPr/>
          </p:nvSpPr>
          <p:spPr>
            <a:xfrm>
              <a:off x="4355813" y="4876650"/>
              <a:ext cx="1660487" cy="672274"/>
            </a:xfrm>
            <a:prstGeom prst="rect">
              <a:avLst/>
            </a:prstGeom>
            <a:solidFill>
              <a:schemeClr val="accent1">
                <a:alpha val="0"/>
              </a:schemeClr>
            </a:solidFill>
            <a:ln w="381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200" dirty="0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Articles manually identified by authors</a:t>
              </a:r>
            </a:p>
            <a:p>
              <a:pPr algn="ctr"/>
              <a:r>
                <a:rPr lang="en-US" sz="1200" dirty="0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(n = 1)</a:t>
              </a:r>
            </a:p>
          </p:txBody>
        </p:sp>
        <p:cxnSp>
          <p:nvCxnSpPr>
            <p:cNvPr id="51" name="Conector recto de flecha 50">
              <a:extLst>
                <a:ext uri="{FF2B5EF4-FFF2-40B4-BE49-F238E27FC236}">
                  <a16:creationId xmlns:a16="http://schemas.microsoft.com/office/drawing/2014/main" id="{F50B7E4B-A5FB-4BA5-BBE4-282B3BF0B7C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865453" y="5212780"/>
              <a:ext cx="1490364" cy="0"/>
            </a:xfrm>
            <a:prstGeom prst="straightConnector1">
              <a:avLst/>
            </a:prstGeom>
            <a:ln w="38100">
              <a:solidFill>
                <a:srgbClr val="2F528F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Rectángulo 57">
              <a:extLst>
                <a:ext uri="{FF2B5EF4-FFF2-40B4-BE49-F238E27FC236}">
                  <a16:creationId xmlns:a16="http://schemas.microsoft.com/office/drawing/2014/main" id="{1C19EF37-4284-44AE-8F95-D9A31A3D49CC}"/>
                </a:ext>
              </a:extLst>
            </p:cNvPr>
            <p:cNvSpPr/>
            <p:nvPr/>
          </p:nvSpPr>
          <p:spPr>
            <a:xfrm>
              <a:off x="1450201" y="2927975"/>
              <a:ext cx="387773" cy="1858029"/>
            </a:xfrm>
            <a:prstGeom prst="rect">
              <a:avLst/>
            </a:prstGeom>
            <a:solidFill>
              <a:srgbClr val="8FAADC"/>
            </a:solidFill>
            <a:ln w="381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vert270" wrap="square" lIns="121920" tIns="60960" rIns="121920" bIns="6096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s-MX" sz="1400" dirty="0">
                  <a:ea typeface="Calibri" panose="020F0502020204030204" pitchFamily="34" charset="0"/>
                  <a:cs typeface="Times New Roman" panose="02020603050405020304" pitchFamily="18" charset="0"/>
                </a:rPr>
                <a:t>REVIEW</a:t>
              </a:r>
            </a:p>
          </p:txBody>
        </p:sp>
        <p:sp>
          <p:nvSpPr>
            <p:cNvPr id="61" name="Rectángulo 60">
              <a:extLst>
                <a:ext uri="{FF2B5EF4-FFF2-40B4-BE49-F238E27FC236}">
                  <a16:creationId xmlns:a16="http://schemas.microsoft.com/office/drawing/2014/main" id="{FD91E0DF-6A37-410E-8EC7-86141A8EB10F}"/>
                </a:ext>
              </a:extLst>
            </p:cNvPr>
            <p:cNvSpPr/>
            <p:nvPr/>
          </p:nvSpPr>
          <p:spPr>
            <a:xfrm>
              <a:off x="1450203" y="4876650"/>
              <a:ext cx="387773" cy="1739303"/>
            </a:xfrm>
            <a:prstGeom prst="rect">
              <a:avLst/>
            </a:prstGeom>
            <a:solidFill>
              <a:srgbClr val="8FAADC"/>
            </a:solidFill>
            <a:ln w="381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vert270" wrap="square" lIns="121920" tIns="60960" rIns="121920" bIns="6096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s-MX" sz="1400" dirty="0">
                  <a:ea typeface="Calibri" panose="020F0502020204030204" pitchFamily="34" charset="0"/>
                  <a:cs typeface="Times New Roman" panose="02020603050405020304" pitchFamily="18" charset="0"/>
                </a:rPr>
                <a:t>INCLUDE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5546287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3</TotalTime>
  <Words>85</Words>
  <Application>Microsoft Office PowerPoint</Application>
  <PresentationFormat>Personalizado</PresentationFormat>
  <Paragraphs>22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rnando Garcia R.</dc:creator>
  <cp:lastModifiedBy>Fernando Garcia R.</cp:lastModifiedBy>
  <cp:revision>39</cp:revision>
  <dcterms:created xsi:type="dcterms:W3CDTF">2019-05-17T17:54:07Z</dcterms:created>
  <dcterms:modified xsi:type="dcterms:W3CDTF">2019-06-21T14:00:49Z</dcterms:modified>
</cp:coreProperties>
</file>